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81" r:id="rId2"/>
    <p:sldId id="287" r:id="rId3"/>
    <p:sldId id="284" r:id="rId4"/>
    <p:sldId id="288" r:id="rId5"/>
    <p:sldId id="280" r:id="rId6"/>
    <p:sldId id="285" r:id="rId7"/>
    <p:sldId id="291" r:id="rId8"/>
    <p:sldId id="292" r:id="rId9"/>
  </p:sldIdLst>
  <p:sldSz cx="12192000" cy="16256000"/>
  <p:notesSz cx="6888163" cy="100187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20" autoAdjust="0"/>
    <p:restoredTop sz="94660"/>
  </p:normalViewPr>
  <p:slideViewPr>
    <p:cSldViewPr snapToGrid="0">
      <p:cViewPr varScale="1">
        <p:scale>
          <a:sx n="41" d="100"/>
          <a:sy n="41" d="100"/>
        </p:scale>
        <p:origin x="231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9392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5576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92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4145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66116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6910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170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5360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9646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0344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406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76964A-ADCD-42BE-9320-9F2732CEE548}" type="datetimeFigureOut">
              <a:rPr lang="ko-KR" altLang="en-US" smtClean="0"/>
              <a:t>2023-12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E6DD6-ADCA-49ED-AF48-3D5B0CBA97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915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1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1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1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1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10" Type="http://schemas.openxmlformats.org/officeDocument/2006/relationships/image" Target="../media/image17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eg"/><Relationship Id="rId5" Type="http://schemas.openxmlformats.org/officeDocument/2006/relationships/image" Target="../media/image21.jpeg"/><Relationship Id="rId10" Type="http://schemas.openxmlformats.org/officeDocument/2006/relationships/image" Target="../media/image26.jpeg"/><Relationship Id="rId4" Type="http://schemas.openxmlformats.org/officeDocument/2006/relationships/image" Target="../media/image20.jpeg"/><Relationship Id="rId9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7161" y="2317351"/>
            <a:ext cx="8508330" cy="8027230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447470" y="10926171"/>
            <a:ext cx="114202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800"/>
              </a:spcAft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ion and purification of active compound.  </a:t>
            </a:r>
            <a:endParaRPr lang="ko-KR" altLang="ko-KR" sz="20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endParaRPr lang="ko-KR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3033162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447470" y="8455344"/>
            <a:ext cx="11420273" cy="32726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Antiviral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of </a:t>
            </a:r>
            <a:r>
              <a:rPr lang="en-US" altLang="ko-KR" sz="2000" b="1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,chinensis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ainst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VB3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ko-KR" sz="200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 </a:t>
            </a:r>
            <a:endParaRPr lang="ko-KR" altLang="ko-KR" sz="20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2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o cells were infected with </a:t>
            </a:r>
            <a:r>
              <a:rPr lang="en-GB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×10</a:t>
            </a:r>
            <a:r>
              <a:rPr lang="en-GB" altLang="ko-KR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FU </a:t>
            </a:r>
            <a:r>
              <a:rPr lang="en-US" altLang="ko-KR" sz="20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VB3 at </a:t>
            </a:r>
            <a:r>
              <a:rPr lang="en-US" altLang="ko-KR" sz="2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% cell culture infective dose (CCID</a:t>
            </a:r>
            <a:r>
              <a:rPr lang="en-US" altLang="ko-KR" sz="200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ko-KR" sz="2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treated with </a:t>
            </a:r>
            <a:r>
              <a:rPr lang="en-US" altLang="ko-KR" sz="20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.chinensis</a:t>
            </a:r>
            <a:r>
              <a:rPr lang="en-US" altLang="ko-KR" sz="2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RB assay was used to measure cell viability. The results are shown as mean ± SEM. *** </a:t>
            </a:r>
            <a:r>
              <a:rPr lang="en-US" altLang="ko-KR" sz="20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01 for comparison with the CVB3-infected vehicle-treated group (V) based on One-Way ANOVA with </a:t>
            </a:r>
            <a:r>
              <a:rPr lang="en-US" altLang="ko-KR" sz="20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nferroni’s</a:t>
            </a:r>
            <a:r>
              <a:rPr lang="en-US" altLang="ko-KR" sz="20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 test.</a:t>
            </a:r>
            <a:endParaRPr lang="ko-KR" altLang="ko-KR" sz="20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8512337" y="315700"/>
            <a:ext cx="327846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sz="2400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2655" y="3179612"/>
            <a:ext cx="6080424" cy="47254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9382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7" descr="Saucerneol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9048" y="3183054"/>
            <a:ext cx="8553192" cy="3925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직사각형 4"/>
          <p:cNvSpPr/>
          <p:nvPr/>
        </p:nvSpPr>
        <p:spPr>
          <a:xfrm>
            <a:off x="447470" y="8027328"/>
            <a:ext cx="11420273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800"/>
              </a:spcAft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kern="0" dirty="0">
                <a:latin typeface="Times New Roman" panose="02020603050405020304" pitchFamily="18" charset="0"/>
                <a:ea typeface="Times-Italic"/>
                <a:cs typeface="Times New Roman" panose="02020603050405020304" pitchFamily="18" charset="0"/>
              </a:rPr>
              <a:t>Structure of </a:t>
            </a:r>
            <a:r>
              <a:rPr lang="en-US" altLang="ko-KR" sz="20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b="1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1600" kern="100" dirty="0" smtClean="0">
                <a:latin typeface="맑은 고딕" panose="020B0503020000020004" pitchFamily="50" charset="-127"/>
                <a:cs typeface="Times New Roman" panose="02020603050405020304" pitchFamily="18" charset="0"/>
              </a:rPr>
              <a:t>.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endParaRPr lang="ko-KR" altLang="ko-KR" sz="20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3589269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408560" y="9739395"/>
            <a:ext cx="11420273" cy="32726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activity of </a:t>
            </a:r>
            <a:r>
              <a:rPr lang="en-US" altLang="ko-K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VB3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ko-KR" sz="2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tro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o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infected with CVB3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with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Cell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and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Cytotoxicity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were measured using SRB assay.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pintrivir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as a positive control. The results are shown as mean ± SEM. *** </a:t>
            </a:r>
            <a:r>
              <a:rPr lang="en-US" altLang="ko-KR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01 for comparison with the CVB3-infected vehicle-treated group (V) based on One-Way ANOVA with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nferroni’s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 test.</a:t>
            </a:r>
            <a:endParaRPr lang="ko-KR" altLang="ko-KR" sz="20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2400" dirty="0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4355" y="5086810"/>
            <a:ext cx="5353388" cy="4182198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463" y="5086810"/>
            <a:ext cx="5884233" cy="455102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4463" y="4512808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514355" y="4512808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015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0696" y="2751078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255944" y="2751078"/>
            <a:ext cx="68480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408560" y="8610988"/>
            <a:ext cx="11420273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activity of </a:t>
            </a:r>
            <a:r>
              <a:rPr lang="en-US" altLang="ko-K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inst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VA16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 </a:t>
            </a:r>
          </a:p>
          <a:p>
            <a:pPr algn="just">
              <a:lnSpc>
                <a:spcPct val="200000"/>
              </a:lnSpc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Vero cells were infected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CVA16 and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with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ell viability by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were measured using SRB assay. (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lative CVA16 5’NCR gene expression in CVA16-infected Vero cells was determined using real-time PCR.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pintrivir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used as a positive control. The results are shown as mean ± SEM. * </a:t>
            </a:r>
            <a:r>
              <a:rPr lang="en-US" altLang="ko-KR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5, ** </a:t>
            </a:r>
            <a:r>
              <a:rPr lang="en-US" altLang="ko-KR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1, and *** </a:t>
            </a:r>
            <a:r>
              <a:rPr lang="en-US" altLang="ko-KR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01 for comparison with the CVA16-infected vehicle-treated group (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ased on One-Way ANOVA with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nferroni’s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 test.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24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8696" y="3309379"/>
            <a:ext cx="6048000" cy="5428668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96" y="3309379"/>
            <a:ext cx="6048000" cy="5231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52792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408560" y="8610988"/>
            <a:ext cx="11420273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viral activity of </a:t>
            </a:r>
            <a:r>
              <a:rPr lang="en-US" altLang="ko-KR" sz="20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OS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uced by </a:t>
            </a:r>
            <a:r>
              <a:rPr lang="en-US" altLang="ko-KR" sz="20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acerneol</a:t>
            </a:r>
            <a:r>
              <a:rPr lang="en-US" altLang="ko-KR" sz="20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gainst 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VA16</a:t>
            </a:r>
          </a:p>
          <a:p>
            <a:pPr algn="just">
              <a:lnSpc>
                <a:spcPct val="200000"/>
              </a:lnSpc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ko-KR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 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 of M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o-Tempo were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ed to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ko-KR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erneol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reated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VA16-infected cells. The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are shown as mean ± SEM. * </a:t>
            </a:r>
            <a:r>
              <a:rPr lang="en-US" altLang="ko-KR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&lt; 0.05 for comparison with the CVA16-infected vehicle-treated group (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h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ased on One-Way ANOVA with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nferroni’s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ltiple comparison test.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2400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2576" y="3178687"/>
            <a:ext cx="5992240" cy="4953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28103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>
            <a:off x="447470" y="12846575"/>
            <a:ext cx="11420273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ucerneol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uced the STING/TBK-1/IRF3 signaling pathway in Enterovirus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1-infected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</a:p>
          <a:p>
            <a:pPr algn="just">
              <a:lnSpc>
                <a:spcPct val="200000"/>
              </a:lnSpc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nsity of western blot bands was calculated as the relative expression of STING, p-STING, TBK-1, p-TBK-1, IRF-3, and p-IRF-3. Each band was normalized against the density of the corresponding β-actin band.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2400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4417" y="1754154"/>
            <a:ext cx="4191219" cy="3590609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1636" y="8934424"/>
            <a:ext cx="4191219" cy="3590609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275" y="5344288"/>
            <a:ext cx="4191219" cy="3590609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275" y="8934423"/>
            <a:ext cx="4191219" cy="3590609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4417" y="5345237"/>
            <a:ext cx="4191219" cy="3590609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4417" y="8935845"/>
            <a:ext cx="4191219" cy="3590609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275" y="1754154"/>
            <a:ext cx="4191219" cy="359060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3280" y="5344987"/>
            <a:ext cx="4189575" cy="35892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3279" y="1754852"/>
            <a:ext cx="4189576" cy="358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29673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직사각형 6"/>
          <p:cNvSpPr/>
          <p:nvPr/>
        </p:nvSpPr>
        <p:spPr>
          <a:xfrm>
            <a:off x="8512337" y="315700"/>
            <a:ext cx="335540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ko-KR" alt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ko-KR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2400" dirty="0"/>
          </a:p>
        </p:txBody>
      </p:sp>
      <p:sp>
        <p:nvSpPr>
          <p:cNvPr id="20" name="직사각형 19"/>
          <p:cNvSpPr/>
          <p:nvPr/>
        </p:nvSpPr>
        <p:spPr>
          <a:xfrm>
            <a:off x="447470" y="12782207"/>
            <a:ext cx="11420273" cy="25545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ko-KR" sz="2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ko-KR" sz="20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ucerneol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uced the STING/TBK-1/IRF3 signaling pathway in Coxsackievirus A16</a:t>
            </a:r>
            <a:r>
              <a:rPr lang="en-US" altLang="ko-K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infected </a:t>
            </a:r>
            <a:r>
              <a:rPr lang="en-US" altLang="ko-KR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</a:p>
          <a:p>
            <a:pPr algn="just">
              <a:lnSpc>
                <a:spcPct val="200000"/>
              </a:lnSpc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nsity of western blot bands was calculated as the relative expression of STING, p-STING, TBK-1, p-TBK-1, IRF-3, and p-IRF-3. Each band was normalized against the density of the corresponding β-actin band.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902" y="8960912"/>
            <a:ext cx="4189575" cy="3589200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609" y="5371838"/>
            <a:ext cx="4189575" cy="35892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607" y="8960534"/>
            <a:ext cx="4189575" cy="3589200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902" y="1782764"/>
            <a:ext cx="4189575" cy="3589200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2610" y="1783016"/>
            <a:ext cx="4189575" cy="358920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1312" y="8966082"/>
            <a:ext cx="4189575" cy="358920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902" y="5371838"/>
            <a:ext cx="4189575" cy="3589200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1311" y="5368560"/>
            <a:ext cx="4189576" cy="3589200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1312" y="1785349"/>
            <a:ext cx="4189575" cy="358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1653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562</TotalTime>
  <Words>207</Words>
  <Application>Microsoft Office PowerPoint</Application>
  <PresentationFormat>사용자 지정</PresentationFormat>
  <Paragraphs>26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5" baseType="lpstr">
      <vt:lpstr>Times-Italic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송재형</dc:creator>
  <cp:lastModifiedBy>Sun-Young Chang</cp:lastModifiedBy>
  <cp:revision>115</cp:revision>
  <cp:lastPrinted>2023-07-24T07:27:02Z</cp:lastPrinted>
  <dcterms:created xsi:type="dcterms:W3CDTF">2020-04-21T07:29:23Z</dcterms:created>
  <dcterms:modified xsi:type="dcterms:W3CDTF">2023-12-16T08:19:29Z</dcterms:modified>
</cp:coreProperties>
</file>